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83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8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104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783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763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6978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0216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179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990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945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736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472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C3FECE-7451-4721-8650-59A8AA23B42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C0F0C-AFC9-49E7-9E3E-5479A7D83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758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2350" y="237129"/>
            <a:ext cx="6189970" cy="5135551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1577515" y="2841407"/>
            <a:ext cx="367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74309" y="3141026"/>
            <a:ext cx="367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577515" y="3440645"/>
            <a:ext cx="367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574309" y="3740264"/>
            <a:ext cx="367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74309" y="4039883"/>
            <a:ext cx="367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684915" y="433950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531027" y="4639123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+mj-lt"/>
                <a:ea typeface="Arial Unicode MS" panose="020B0604020202020204" pitchFamily="50" charset="-128"/>
                <a:cs typeface="Times New Roman" panose="02020603050405020304" pitchFamily="18" charset="0"/>
              </a:rPr>
              <a:t>-0.5</a:t>
            </a: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1073267" y="1136287"/>
            <a:ext cx="85151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/>
              <a:t>Odds ratio</a:t>
            </a:r>
            <a:endParaRPr kumimoji="1" lang="ja-JP" altLang="en-US" sz="1200" b="1" dirty="0"/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869587" y="3637940"/>
            <a:ext cx="130035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+mj-lt"/>
              </a:rPr>
              <a:t>log10(Odds ratio)</a:t>
            </a:r>
            <a:endParaRPr kumimoji="1" lang="ja-JP" altLang="en-US" sz="1200" b="1" dirty="0">
              <a:latin typeface="+mj-lt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187624" y="5247128"/>
            <a:ext cx="669674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Risk estimation according to Polygenic Risk Score for NASH and NASH-HCC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comparing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teon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4+NASH-HCC with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teon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s 1-3, and comparing NASH-HCC with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teon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4 are shown in the upper (A, B) and lower (C, D) panels, respectively. The dots and bars in A and C denote the odds ratio and its 95% confidence interval in each quintile compared to the 1st quintile. Red ROC curves in B and D were calculated by the model constructed from genome-wide significant SNPs. Green lines represent the model obtained when known SNPs were added. Black lines represent the model obtained using SNPs with a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less than 1x10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each GWA study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577993" y="-95462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719373" y="-95462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B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397682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44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kawa</dc:creator>
  <cp:lastModifiedBy>tkawa</cp:lastModifiedBy>
  <cp:revision>19</cp:revision>
  <cp:lastPrinted>2017-06-23T04:42:13Z</cp:lastPrinted>
  <dcterms:created xsi:type="dcterms:W3CDTF">2017-06-09T05:08:35Z</dcterms:created>
  <dcterms:modified xsi:type="dcterms:W3CDTF">2017-08-25T16:54:52Z</dcterms:modified>
</cp:coreProperties>
</file>